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26" d="100"/>
          <a:sy n="126" d="100"/>
        </p:scale>
        <p:origin x="-1290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8E9B00-6070-4E07-9786-709EBB791C65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DB1C7-80A6-489F-89D7-83AD43B5DE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07474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8E9B00-6070-4E07-9786-709EBB791C65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DB1C7-80A6-489F-89D7-83AD43B5DE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34860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8E9B00-6070-4E07-9786-709EBB791C65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DB1C7-80A6-489F-89D7-83AD43B5DE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51570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8E9B00-6070-4E07-9786-709EBB791C65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DB1C7-80A6-489F-89D7-83AD43B5DE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51063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8E9B00-6070-4E07-9786-709EBB791C65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DB1C7-80A6-489F-89D7-83AD43B5DE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19384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8E9B00-6070-4E07-9786-709EBB791C65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DB1C7-80A6-489F-89D7-83AD43B5DE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18350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8E9B00-6070-4E07-9786-709EBB791C65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DB1C7-80A6-489F-89D7-83AD43B5DE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65481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8E9B00-6070-4E07-9786-709EBB791C65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DB1C7-80A6-489F-89D7-83AD43B5DE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73570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8E9B00-6070-4E07-9786-709EBB791C65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DB1C7-80A6-489F-89D7-83AD43B5DE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51200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8E9B00-6070-4E07-9786-709EBB791C65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DB1C7-80A6-489F-89D7-83AD43B5DE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69526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8E9B00-6070-4E07-9786-709EBB791C65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DB1C7-80A6-489F-89D7-83AD43B5DE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02998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8E9B00-6070-4E07-9786-709EBB791C65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FDB1C7-80A6-489F-89D7-83AD43B5DE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73376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Tableau 4">
            <a:extLst>
              <a:ext uri="{FF2B5EF4-FFF2-40B4-BE49-F238E27FC236}">
                <a16:creationId xmlns:a16="http://schemas.microsoft.com/office/drawing/2014/main" xmlns="" id="{1B151571-FA8F-41E5-AEF6-E808C8E7F27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99683479"/>
              </p:ext>
            </p:extLst>
          </p:nvPr>
        </p:nvGraphicFramePr>
        <p:xfrm>
          <a:off x="1143000" y="965692"/>
          <a:ext cx="7344000" cy="43200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12000">
                  <a:extLst>
                    <a:ext uri="{9D8B030D-6E8A-4147-A177-3AD203B41FA5}">
                      <a16:colId xmlns:a16="http://schemas.microsoft.com/office/drawing/2014/main" xmlns="" val="431434200"/>
                    </a:ext>
                  </a:extLst>
                </a:gridCol>
                <a:gridCol w="560594">
                  <a:extLst>
                    <a:ext uri="{9D8B030D-6E8A-4147-A177-3AD203B41FA5}">
                      <a16:colId xmlns:a16="http://schemas.microsoft.com/office/drawing/2014/main" xmlns="" val="1539161484"/>
                    </a:ext>
                  </a:extLst>
                </a:gridCol>
                <a:gridCol w="663406">
                  <a:extLst>
                    <a:ext uri="{9D8B030D-6E8A-4147-A177-3AD203B41FA5}">
                      <a16:colId xmlns:a16="http://schemas.microsoft.com/office/drawing/2014/main" xmlns="" val="3242765056"/>
                    </a:ext>
                  </a:extLst>
                </a:gridCol>
                <a:gridCol w="612000">
                  <a:extLst>
                    <a:ext uri="{9D8B030D-6E8A-4147-A177-3AD203B41FA5}">
                      <a16:colId xmlns:a16="http://schemas.microsoft.com/office/drawing/2014/main" xmlns="" val="2404456471"/>
                    </a:ext>
                  </a:extLst>
                </a:gridCol>
                <a:gridCol w="612000">
                  <a:extLst>
                    <a:ext uri="{9D8B030D-6E8A-4147-A177-3AD203B41FA5}">
                      <a16:colId xmlns:a16="http://schemas.microsoft.com/office/drawing/2014/main" xmlns="" val="1221875639"/>
                    </a:ext>
                  </a:extLst>
                </a:gridCol>
                <a:gridCol w="612000">
                  <a:extLst>
                    <a:ext uri="{9D8B030D-6E8A-4147-A177-3AD203B41FA5}">
                      <a16:colId xmlns:a16="http://schemas.microsoft.com/office/drawing/2014/main" xmlns="" val="3700146904"/>
                    </a:ext>
                  </a:extLst>
                </a:gridCol>
                <a:gridCol w="612000">
                  <a:extLst>
                    <a:ext uri="{9D8B030D-6E8A-4147-A177-3AD203B41FA5}">
                      <a16:colId xmlns:a16="http://schemas.microsoft.com/office/drawing/2014/main" xmlns="" val="1974387459"/>
                    </a:ext>
                  </a:extLst>
                </a:gridCol>
                <a:gridCol w="612000">
                  <a:extLst>
                    <a:ext uri="{9D8B030D-6E8A-4147-A177-3AD203B41FA5}">
                      <a16:colId xmlns:a16="http://schemas.microsoft.com/office/drawing/2014/main" xmlns="" val="877447223"/>
                    </a:ext>
                  </a:extLst>
                </a:gridCol>
                <a:gridCol w="612000">
                  <a:extLst>
                    <a:ext uri="{9D8B030D-6E8A-4147-A177-3AD203B41FA5}">
                      <a16:colId xmlns:a16="http://schemas.microsoft.com/office/drawing/2014/main" xmlns="" val="1324231485"/>
                    </a:ext>
                  </a:extLst>
                </a:gridCol>
                <a:gridCol w="612000">
                  <a:extLst>
                    <a:ext uri="{9D8B030D-6E8A-4147-A177-3AD203B41FA5}">
                      <a16:colId xmlns:a16="http://schemas.microsoft.com/office/drawing/2014/main" xmlns="" val="1090415596"/>
                    </a:ext>
                  </a:extLst>
                </a:gridCol>
                <a:gridCol w="612000">
                  <a:extLst>
                    <a:ext uri="{9D8B030D-6E8A-4147-A177-3AD203B41FA5}">
                      <a16:colId xmlns:a16="http://schemas.microsoft.com/office/drawing/2014/main" xmlns="" val="3378420055"/>
                    </a:ext>
                  </a:extLst>
                </a:gridCol>
                <a:gridCol w="612000">
                  <a:extLst>
                    <a:ext uri="{9D8B030D-6E8A-4147-A177-3AD203B41FA5}">
                      <a16:colId xmlns:a16="http://schemas.microsoft.com/office/drawing/2014/main" xmlns="" val="3718458419"/>
                    </a:ext>
                  </a:extLst>
                </a:gridCol>
              </a:tblGrid>
              <a:tr h="288000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ortality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T0, start 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3 weeks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6 weeks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9 weeks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End - 12 weeks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xmlns="" val="2960059284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14-juin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05-juil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26-juil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16-août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06-sept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487337581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Tank n°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diet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fish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dead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fish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dead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fish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dead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fish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dead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fish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dead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xmlns="" val="544771964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R8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HS-0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2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2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2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2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2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xmlns="" val="3620513513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S4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HS-0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2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2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2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xmlns="" val="1608540775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S6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HS-0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2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2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2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2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xmlns="" val="4292241619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R6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HS-In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2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2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2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xmlns="" val="2080793007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S1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HS-In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2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2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xmlns="" val="1035597877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S7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HS-In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2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2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xmlns="" val="1459956764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R7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LS-0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2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2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2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xmlns="" val="3208075697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S2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LS-0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2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2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xmlns="" val="2358379663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S8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LS-0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2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2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2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2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xmlns="" val="1449626942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R5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LS-In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2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2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2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xmlns="" val="2635440647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S3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LS-In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2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2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2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xmlns="" val="914927900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S5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LS-In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2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2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2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2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2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331830215"/>
                  </a:ext>
                </a:extLst>
              </a:tr>
            </a:tbl>
          </a:graphicData>
        </a:graphic>
      </p:graphicFrame>
      <p:sp>
        <p:nvSpPr>
          <p:cNvPr id="9" name="ZoneTexte 5">
            <a:extLst>
              <a:ext uri="{FF2B5EF4-FFF2-40B4-BE49-F238E27FC236}">
                <a16:creationId xmlns:a16="http://schemas.microsoft.com/office/drawing/2014/main" xmlns="" id="{568DF690-81C0-4D28-9901-AB469118E300}"/>
              </a:ext>
            </a:extLst>
          </p:cNvPr>
          <p:cNvSpPr txBox="1"/>
          <p:nvPr/>
        </p:nvSpPr>
        <p:spPr>
          <a:xfrm>
            <a:off x="945474" y="475487"/>
            <a:ext cx="76078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Additional file 1. Table S1: </a:t>
            </a:r>
            <a:r>
              <a:rPr lang="en-US" sz="1200" dirty="0"/>
              <a:t>Mortality count per tanks in fish fed the experimental diets during 12 weeks. 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20562672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98</Words>
  <Application>Microsoft Office PowerPoint</Application>
  <PresentationFormat>On-screen Show (4:3)</PresentationFormat>
  <Paragraphs>16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tonieta Decipolo</dc:creator>
  <cp:lastModifiedBy>Antonieta Decipolo</cp:lastModifiedBy>
  <cp:revision>1</cp:revision>
  <dcterms:created xsi:type="dcterms:W3CDTF">2023-10-22T23:58:55Z</dcterms:created>
  <dcterms:modified xsi:type="dcterms:W3CDTF">2023-10-23T00:00:41Z</dcterms:modified>
</cp:coreProperties>
</file>